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315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618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488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217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240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504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657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653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698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900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036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4CD79-5CF2-4518-B46C-A41913941767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2D043-1015-445D-8BCC-7E55E59138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327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848654" y="311353"/>
            <a:ext cx="51389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ouse vs Human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Activin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rotein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lignment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311160" y="982297"/>
            <a:ext cx="7881668" cy="48351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    </a:t>
            </a:r>
            <a:r>
              <a:rPr lang="en-US" sz="1200" b="1" u="sng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ASSLLLALLFLTPTTVV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PKTEGPCPACWGAIFDLESQRELLLDLAKKSILDKLHLSQR  60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M SSLLLA L </a:t>
            </a:r>
            <a:r>
              <a:rPr lang="en-US" sz="1200" dirty="0" err="1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PTTV  P+  G CPAC G   +LESQRELLLDLAK+SILDKLHL+QR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b="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    </a:t>
            </a:r>
            <a:r>
              <a:rPr lang="en-US" sz="1200" b="1" u="sng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TSSLLLAFLLLAPTTVA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PRAGGQCPACGGPTLELESQRELLLDLAKRSILDKLHLTQR  60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61   PILSRPVSRGALKTALQRLRGPRRETLLEHDQRQEEYEIISFADTDLSSINQTRLEFHFS  120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P L+RPVSR AL+TALQ L G  +  LLE D R++E EIISFA+T LS+INQTRL+FHFS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61   PTLNRPVSRAALRTALQHLHGVPQGALLE-DNREQECEIISFAETGLSTINQTRLDFHFS  119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21  G-RMASGMEVRQTRFMFFVQFPHNATQTMNIRVLVLRPYDTNLTLTSQYVVQVNASGWYQ  179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R A   EV+Q   MFFVQ P N T </a:t>
            </a:r>
            <a:r>
              <a:rPr lang="en-US" sz="1200" dirty="0" err="1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+ +RVLVL P++TNLTL +QY+++V+ASGW+Q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20  SDRTAGDREVQQASLMFFVQLPSNTTWTLKVRVLVLGPHNTNLTLATQYLLEVDASGWHQ  179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80  LLLGPEAQAACSQGHLTLELVPESQVAHSSLILGWFSHRPFVAAQVRVEGKHRV</a:t>
            </a:r>
            <a:r>
              <a:rPr lang="en-US" sz="1200" b="1" dirty="0">
                <a:solidFill>
                  <a:srgbClr val="FF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RR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ID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239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L LGPEAQAACSQGHLTLELV E QVA SS+ILG  +HRPFVAA+VRV GKH++ RRGID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180  LPLGPEAQAACSQGHLTLELVLEGQVAQSSVILGGAAHRPFVAARVRVGGKHQI</a:t>
            </a:r>
            <a:r>
              <a:rPr lang="en-US" sz="1200" b="1" dirty="0">
                <a:solidFill>
                  <a:srgbClr val="FF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RR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ID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239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240  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QGASRMCCRQEFFVDFREIGWNDWIIQPEGYAMNFCTGQCPLHVAGMPGISASFHTAVL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299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CQG SRMCCRQEFFVDFREIGW+DWIIQPEGYAMNFC GQCPLH+AGMPGI+ASFHTAVL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240  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QGGSRMCCRQEFFVDFREIGWHDWIIQPEGYAMNFCIGQCPLHIAGMPGIAASFHTAVL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299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ouse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300  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LLKANAAAGTTGRGSCCVPTSRRPLSLLYYDRDSNIVKTDIPDMVVEACGCS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352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NLLKAN AAGTTG GSCCVPT+RRPLSLLYYDRDSNIVKTDIPDMVVEACGCS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uman</a:t>
            </a:r>
            <a:r>
              <a:rPr lang="en-US" sz="1200" dirty="0" smtClean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300  </a:t>
            </a:r>
            <a:r>
              <a:rPr lang="en-US" sz="1200" b="1" dirty="0">
                <a:solidFill>
                  <a:srgbClr val="00B05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LLKANTAAGTTGGGSCCVPTARRPLSLLYYDRDSNIVKTDIPDMVVEACGCS</a:t>
            </a: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352</a:t>
            </a:r>
            <a:endParaRPr lang="en-US" sz="1200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2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685026" y="6119079"/>
            <a:ext cx="8908211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3 Fig. Amino acid alignment of full-length Act C proteins from mouse (accession NP_034695) and human (accession </a:t>
            </a:r>
            <a:r>
              <a:rPr lang="en-US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P_005529</a:t>
            </a:r>
            <a:r>
              <a:rPr lang="en-US" sz="120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5725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1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>The Children's Hospital of Philadelph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llings, Paul C</dc:creator>
  <cp:lastModifiedBy>Billings, Paul C</cp:lastModifiedBy>
  <cp:revision>2</cp:revision>
  <dcterms:created xsi:type="dcterms:W3CDTF">2020-01-03T20:36:22Z</dcterms:created>
  <dcterms:modified xsi:type="dcterms:W3CDTF">2020-01-06T18:39:44Z</dcterms:modified>
</cp:coreProperties>
</file>